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2"/>
    <p:restoredTop sz="95827"/>
  </p:normalViewPr>
  <p:slideViewPr>
    <p:cSldViewPr snapToGrid="0" snapToObjects="1">
      <p:cViewPr varScale="1">
        <p:scale>
          <a:sx n="100" d="100"/>
          <a:sy n="100" d="100"/>
        </p:scale>
        <p:origin x="168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877BEF-3F79-0645-8B93-07419C9E08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3903F49-9FD6-DE4E-AAD5-D81F4DC060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0EBCCDE-B5A0-2E46-947D-5C8DB6E3E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C67AC7-B6FD-6B4F-8CD0-9ECC2D64A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BAC460-F71E-484D-8BA8-8B8E59EC0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21025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8E5CDC-BA76-2C4F-8D52-F991B01B91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F54A1C4-1654-1B49-A171-E778A07A62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DC6E7D-7FDE-5540-88C6-992362676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E19DD0E-D6C9-534C-BBE7-C78204E94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690D96-13C5-DE49-BB49-4BBC645942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07182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E43FD09-9837-C14C-BAB7-0486923860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6EADD5E-4A3D-8B47-8A60-B0A898CE40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330D63-AB63-5D4D-AFB6-2D2716A91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9BD126-EFB6-CD4B-AFF3-2021D3D71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9D2246-CB1C-2443-AE9C-674DA8931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14415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C7449E-35CF-5F4B-B982-F2F3B0B84C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B67299B-29DC-684B-BD6B-CB6993C41C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F7F65D0-4BE1-7741-A608-52AC0CDAA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BBC7F2-FEDA-B04A-840B-624392192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5AD434-6C89-E941-A84C-68E681708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83765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6D8FD4-EA17-8844-91A4-7012245BB9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8E1010-11F0-5445-A22A-A743EEE324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C6BACD-86FD-4E45-92AE-ED4D7F00E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2B2826-D81A-1A49-99C8-A3EDE7BC1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C1F273D-24B4-2147-A6C1-AE45A8430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96048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FB7D26-C717-8144-8275-D813FB17B2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B296A7E-DC6B-834D-AF77-DED62C3F2B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2C3E2E8-F267-7140-94F0-2EBB886ACC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42A6F02-9656-A14D-BCB3-8CD706E79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B1174EF-5A6F-B549-A4C1-BB4A2D2A6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2DC2BFE-D0F4-DA4A-A1DF-39DC255D4F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85796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0FAEAE-540E-024E-8C54-FD93C93235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2967BD-4F44-3E49-B5E9-73C5C0A279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893A4F-29D7-4446-8CD6-32340E6F93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3316264-0971-BF49-A9DF-9CA3A0C58C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5FD5989-0E26-874C-8E25-42E3E0438D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DC7174F-F9C3-9944-9237-F866CBFA9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3CC1D50-BBDA-E141-A344-6A5B69217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4D53C92-18AF-1E44-89FC-96346B23C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04910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E78A31-0B10-C34F-A3A2-0F35162D6D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023A1C0-16CB-7E4D-9736-1A537D0FC7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0838C6F-D931-2742-AB7D-981C71959C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A425860-CC3B-3747-A28A-A9C820741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9721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3E74D50-9A21-554F-9309-43F897D055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C527858-2938-F949-BBB1-20CCC536C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B29025F-947A-DB4E-B1D9-CDCCCFEEAF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3297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90134B-6B4C-C54E-9E5F-D986B24EAA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8F6D28E-7F24-8748-9904-E323ABF29D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7CFEB0-86CD-C049-B744-36A0DEF0C1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89DB35-2ECA-924E-A88A-1AECB764A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AB25F65-EE51-074B-AC00-4B5D5E81C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DEA6D94-DA1B-A341-924C-9FE0ABC8C6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84297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5E09AC-536F-7944-8748-5F546A36E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B4F7CD8-C376-B74B-883D-B4E0917EE0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111FAA-090B-1141-8868-C150CC2A29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498C07-CAB8-9D43-BC0A-FD1CBF8A0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3008AF5-1990-AE40-9782-60E442790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8C8E5BA-358C-C449-9FBC-B57B309A3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349314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7D6FA5B-545D-0540-AA47-3C24191FE1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0A4725-85A8-A440-8C44-FFED7F65AD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4FB1E6-5E8F-DC4A-B832-AB9F5FF7F7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CB952-4A34-B54D-92F6-400F5DD60BE2}" type="datetimeFigureOut">
              <a:rPr kumimoji="1" lang="zh-CN" altLang="en-US" smtClean="0"/>
              <a:t>2022/7/30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C0F723-56DC-5A43-838A-B247F5E50C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DA61ED-C431-7E45-A3F5-E32B04D797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1473A-F3BF-7E48-AAF3-F702A751C0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55116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hyperlink" Target="http://www.mbkbase.org/" TargetMode="External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1079262" y="973837"/>
            <a:ext cx="10033476" cy="3620703"/>
            <a:chOff x="723021" y="856186"/>
            <a:chExt cx="10796019" cy="3895878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5DCA14F1-0871-215C-B40B-30355E32A83E}"/>
                </a:ext>
              </a:extLst>
            </p:cNvPr>
            <p:cNvGrpSpPr/>
            <p:nvPr/>
          </p:nvGrpSpPr>
          <p:grpSpPr>
            <a:xfrm>
              <a:off x="723021" y="1375496"/>
              <a:ext cx="10796019" cy="3376568"/>
              <a:chOff x="959633" y="1343299"/>
              <a:chExt cx="10796019" cy="3376568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15CB840A-4D92-6352-7921-31496DB4B7D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76452" r="2297" b="879"/>
              <a:stretch/>
            </p:blipFill>
            <p:spPr>
              <a:xfrm>
                <a:off x="1056756" y="3016226"/>
                <a:ext cx="10440000" cy="355486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A26C45BD-49AF-80E5-456D-4AC35BAAF4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70554" r="2386" b="1269"/>
              <a:stretch/>
            </p:blipFill>
            <p:spPr>
              <a:xfrm>
                <a:off x="959860" y="3385216"/>
                <a:ext cx="10533600" cy="480435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6891A657-6522-CF72-551A-B46A73B840F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76635" r="3141" b="1814"/>
              <a:stretch/>
            </p:blipFill>
            <p:spPr>
              <a:xfrm>
                <a:off x="1023871" y="3873164"/>
                <a:ext cx="10450800" cy="343515"/>
              </a:xfrm>
              <a:prstGeom prst="rect">
                <a:avLst/>
              </a:prstGeom>
            </p:spPr>
          </p:pic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5AFA2641-15F4-A027-E104-1284492EE0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70292" r="2900" b="1327"/>
              <a:stretch/>
            </p:blipFill>
            <p:spPr>
              <a:xfrm>
                <a:off x="959633" y="4238349"/>
                <a:ext cx="10519200" cy="481518"/>
              </a:xfrm>
              <a:prstGeom prst="rect">
                <a:avLst/>
              </a:prstGeom>
            </p:spPr>
          </p:pic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9E1A18DD-41AD-374A-1B2C-03B4BB987B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973652" y="1343299"/>
                <a:ext cx="10782000" cy="1673163"/>
              </a:xfrm>
              <a:prstGeom prst="rect">
                <a:avLst/>
              </a:prstGeom>
            </p:spPr>
          </p:pic>
        </p:grp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CA4270A3-D940-8823-E918-56ED26D345D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037683" y="856186"/>
              <a:ext cx="6120000" cy="429760"/>
            </a:xfrm>
            <a:prstGeom prst="rect">
              <a:avLst/>
            </a:prstGeom>
          </p:spPr>
        </p:pic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6FEF7726-AB1E-9918-8635-03856EE3C543}"/>
              </a:ext>
            </a:extLst>
          </p:cNvPr>
          <p:cNvSpPr txBox="1"/>
          <p:nvPr/>
        </p:nvSpPr>
        <p:spPr>
          <a:xfrm>
            <a:off x="946673" y="5394128"/>
            <a:ext cx="10298654" cy="9079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attern of candidate genes of </a:t>
            </a:r>
            <a:r>
              <a:rPr lang="zh-CN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RAB9.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profiles in various tissues at different developmental ages or cells, and the data were obtained from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8"/>
              </a:rPr>
              <a:t>http://www.mbkbase.org/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PKM, Fragments Per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lobas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Million, indicates gene expression level. Milk, filling and mature represent the developmental stages of rice grain. G-ale indicates grain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euro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s grain embryo and g-ES indicates grain endosperm.</a:t>
            </a:r>
          </a:p>
        </p:txBody>
      </p:sp>
    </p:spTree>
    <p:extLst>
      <p:ext uri="{BB962C8B-B14F-4D97-AF65-F5344CB8AC3E}">
        <p14:creationId xmlns:p14="http://schemas.microsoft.com/office/powerpoint/2010/main" val="2498520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Macintosh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2</cp:revision>
  <dcterms:created xsi:type="dcterms:W3CDTF">2022-07-23T07:52:36Z</dcterms:created>
  <dcterms:modified xsi:type="dcterms:W3CDTF">2022-07-30T12:40:49Z</dcterms:modified>
</cp:coreProperties>
</file>